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/>
    <p:restoredTop sz="94626"/>
  </p:normalViewPr>
  <p:slideViewPr>
    <p:cSldViewPr snapToGrid="0">
      <p:cViewPr varScale="1">
        <p:scale>
          <a:sx n="116" d="100"/>
          <a:sy n="116" d="100"/>
        </p:scale>
        <p:origin x="8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AA730ED-3987-3FFC-B5C7-B7C2487645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25DD135-1558-F8CE-03FD-5CC11FF617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CA"/>
              <a:t>Modifier le style des sous-titres du masque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2F7A073-89DA-6537-18BF-3D23C1017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5741118-CFE4-D186-97F2-C9404C7F6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4AF788A-C58D-FA9E-7ED5-533909020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35480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A985240-3A2D-6FA5-D4F5-43E76B090E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8399E19-F4E5-54F9-F516-C743048721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D084231-4A77-F4B9-FC1D-60E43FF6C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2802025-5243-231B-5C75-AF67615CE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3983B96-307A-6E9F-2702-820A98AF1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8952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0607A99-7904-6786-1A75-B819DBD7F6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D03C921-CA7B-1C7D-95DE-C2CBED87DE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A7721E2-C55A-3AB6-2F37-008D91CBA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3E7BC2D-FE4F-6937-9271-2ED078D8C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E7C4DF1-98F3-D901-1FB1-EB20A2189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9968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EF90AAB-65B7-4271-A573-5171DCFB3B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01DE58C-C142-E3F7-3BB4-EFB84C8FD3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9F5DA68-5814-C904-1AC3-166A09DD3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03FB39F-7A6B-C59E-64D2-FC5534FB9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A620D01-7406-4DEE-B421-66FDA6603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897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9193F0D-EC45-80A6-72E2-A9EEC417EF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0ABC895-FD0F-030C-F2D5-E95D7B3120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D16AD2-F42F-EB94-D1AB-A100D4C0C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441D254-BCBC-0D3C-D725-6E6DC27C2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8D668CD-5F2B-6682-C950-98E1E543C4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6762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713CA2-AA80-453D-624C-BED68DB90C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901C1E0-2D21-FA7A-D355-6859581F89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DAB2E5A-63A0-AEEC-79A1-3F915F0771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7A6A13E-0F7B-8F7B-08A8-AFDB9EA3F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F151412-02E3-497E-D2F4-8A2E275A7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4AEE5E4-343E-B384-BB47-9DEFDADFC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3142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C96F176-9121-880B-671B-5EAC50C200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C68C2AF-320A-C487-6896-43D289EB65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31EF68F-3956-8EC4-0E9D-7BB4E84844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08E926C7-FE8F-F4F4-7D3B-0F4040B05E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8CA8B85-9A04-82A1-A307-19F988AC53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9AEE5C5D-7D59-8023-9452-91163931F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8081D975-5F19-CEF0-42AD-BEC8F45CB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C6EC6C-EC74-EFE9-1D20-7CD6198C8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5875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44C349B-1ABB-C160-CBAE-3F83123256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F036881-1B02-0131-A4A1-2D07A10A2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E89E2FE-EAB4-4FB9-B454-70B74EE6F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8E4419B-15E2-5DB4-CBD6-7B4C41A1D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9173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C3DED46-53C6-C3C5-2A12-DC2F775D7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D85FBA2-939C-5018-7BCD-A91437DE6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69B980F-5E54-9E0B-F2D8-A37A6F22B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9562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66A2043-9FEC-0EB8-AB40-3BBEFDB06B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C3D9D32-A1A7-1B7B-4F5F-5D68D1D092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6D7961D-DDA1-B289-F860-A4220DFD28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C3C1864-62FC-7C6A-7CBA-9055E70B0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C17F252-B8E8-2188-AC50-E3A2C4995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7708FF6-0B8D-77AB-CBCB-A96C84C43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1413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0129EF-5093-D704-5C00-973B50051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4F3B28C-FBDC-142E-E30C-93BC0CB287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AE3E743-D993-72B9-292D-D9AE3373E0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193F59E-3263-A913-5D4C-41E5C7218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A274E95-CBA9-F70D-953D-9DBFB2529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0AA0DEE-E660-075F-D46B-3670980A8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4088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AE4550F-F42B-826F-2645-E12856952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fr-FR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B95AE47-0A17-069C-2C14-89E092B72A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fr-F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7417617-497E-66EB-48BE-C8C44B20E1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66ABA5-FE45-C140-9662-A76788E56C35}" type="datetimeFigureOut">
              <a:rPr lang="fr-FR" smtClean="0"/>
              <a:t>1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1A726EE-58E6-F606-907C-B897CE3DBE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8114660-2314-BE55-6FF0-793BBC9054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1419C98-B528-304B-AA49-294DB545C27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7922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B19A5B10-0625-5EAE-88DD-280F0F6FF3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0539" y="592247"/>
            <a:ext cx="1044226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ile 1. 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centage of respondents who reported different levels of frequency of exposure to sugary beverages advertisements.</a:t>
            </a:r>
            <a:endParaRPr kumimoji="0" lang="en-US" alt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phique 9">
            <a:extLst>
              <a:ext uri="{FF2B5EF4-FFF2-40B4-BE49-F238E27FC236}">
                <a16:creationId xmlns:a16="http://schemas.microsoft.com/office/drawing/2014/main" id="{B996E148-DA4A-1EDF-9AF1-F1DEA5DD893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451610" y="961579"/>
            <a:ext cx="9109710" cy="5612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56813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0</Words>
  <Application>Microsoft Macintosh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Élisabeth Demers-Potvin</dc:creator>
  <cp:lastModifiedBy>Élisabeth Demers-Potvin</cp:lastModifiedBy>
  <cp:revision>2</cp:revision>
  <dcterms:created xsi:type="dcterms:W3CDTF">2024-03-13T18:05:52Z</dcterms:created>
  <dcterms:modified xsi:type="dcterms:W3CDTF">2024-03-13T20:13:02Z</dcterms:modified>
</cp:coreProperties>
</file>